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1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7" d="100"/>
          <a:sy n="57" d="100"/>
        </p:scale>
        <p:origin x="2587" y="67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668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486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825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726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835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133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426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563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10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33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970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593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496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963" r="2073" b="66383"/>
          <a:stretch/>
        </p:blipFill>
        <p:spPr>
          <a:xfrm>
            <a:off x="4520476" y="4966108"/>
            <a:ext cx="2282290" cy="250628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7481"/>
          <a:stretch/>
        </p:blipFill>
        <p:spPr>
          <a:xfrm>
            <a:off x="11765" y="14259"/>
            <a:ext cx="2238062" cy="745542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38" t="16651" r="52740"/>
          <a:stretch/>
        </p:blipFill>
        <p:spPr>
          <a:xfrm>
            <a:off x="2249827" y="6639"/>
            <a:ext cx="2208546" cy="621399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926" t="33463" r="27258"/>
          <a:stretch/>
        </p:blipFill>
        <p:spPr>
          <a:xfrm>
            <a:off x="4535186" y="0"/>
            <a:ext cx="2267580" cy="4960619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38" r="52740" b="83260"/>
          <a:stretch/>
        </p:blipFill>
        <p:spPr>
          <a:xfrm>
            <a:off x="13371" y="7477301"/>
            <a:ext cx="2208546" cy="124803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926" r="27258" b="66537"/>
          <a:stretch/>
        </p:blipFill>
        <p:spPr>
          <a:xfrm>
            <a:off x="2224986" y="6222279"/>
            <a:ext cx="2267580" cy="2494803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09728" y="8906361"/>
            <a:ext cx="66930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0. The Δ(SNP-index) plot obtained by subtraction of LLS resistant pool SNP-index from rust susceptible bulk SNP-index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 confidence intervals under the null hypothesis of no QTL are shown (green: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; orange: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)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94301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80</TotalTime>
  <Words>46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ngh, Vikas (ICRISAT-IN)</dc:creator>
  <cp:lastModifiedBy>Pandey</cp:lastModifiedBy>
  <cp:revision>91</cp:revision>
  <dcterms:created xsi:type="dcterms:W3CDTF">2015-04-20T11:32:42Z</dcterms:created>
  <dcterms:modified xsi:type="dcterms:W3CDTF">2016-09-26T10:49:31Z</dcterms:modified>
</cp:coreProperties>
</file>